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78BDD2-117D-4111-A06F-F2F8B1137D45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5388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6"/>
            <a:ext cx="560832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E0C4B1-694F-49A2-8A07-3F7A7FA048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784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76400" y="228600"/>
            <a:ext cx="632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smtClean="0"/>
              <a:t>S2 </a:t>
            </a:r>
            <a:r>
              <a:rPr lang="en-US" sz="1600" b="1" smtClean="0"/>
              <a:t>Table. </a:t>
            </a:r>
            <a:r>
              <a:rPr lang="en-US" sz="1600" b="1" dirty="0" smtClean="0"/>
              <a:t>Oligonucleotide primers used for </a:t>
            </a:r>
            <a:r>
              <a:rPr lang="en-US" sz="1600" b="1" dirty="0" err="1" smtClean="0"/>
              <a:t>ChIP</a:t>
            </a:r>
            <a:r>
              <a:rPr lang="en-US" sz="1600" b="1" dirty="0" smtClean="0"/>
              <a:t> qPCR and </a:t>
            </a:r>
            <a:r>
              <a:rPr lang="en-US" sz="1600" b="1" dirty="0" err="1" smtClean="0"/>
              <a:t>qRT</a:t>
            </a:r>
            <a:r>
              <a:rPr lang="en-US" sz="1600" b="1" dirty="0" smtClean="0"/>
              <a:t>-PCR</a:t>
            </a:r>
            <a:endParaRPr lang="en-US" sz="1600" b="1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3177394"/>
              </p:ext>
            </p:extLst>
          </p:nvPr>
        </p:nvGraphicFramePr>
        <p:xfrm>
          <a:off x="2057400" y="716280"/>
          <a:ext cx="5791200" cy="5684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67000"/>
                <a:gridCol w="312420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Target sequence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rimer sequence 5’ - 3’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rimers for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ChIP-qPCR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400" kern="1200" dirty="0" smtClean="0">
                        <a:solidFill>
                          <a:schemeClr val="dk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’HS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 GGCTCAAGCACAGCAATGC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CATCACTCTAGGCTGAGAACATCTG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’HS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TCTAAGGACTTGGATTTCAAGGAATT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 CACACCAGCTCGCAAAGTCA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l-GR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ε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globin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omoter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 CACAAACTTAGTGTCCATCCATCAC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CCCTGTTCTCCATGGTACTTAAAAG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-</a:t>
                      </a:r>
                      <a:r>
                        <a:rPr lang="en-US" sz="12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globin</a:t>
                      </a:r>
                      <a:r>
                        <a:rPr lang="en-US" sz="1200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 promoter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CAAATATCTGTCTGAAACGGTCCCT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 TGCCTTGTCAAGGCTATTGGT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l-GR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globin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omoter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GAGGGTTTGAAGTCCAACTCCTAA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CAGGGTGAGGTCTAAGTGATGACA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l-GR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ε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globin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xon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 CAAGCCCGCCTTTGCTAAG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CACCTTGAAGTTCTCAGGATCCA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-</a:t>
                      </a:r>
                      <a:r>
                        <a:rPr lang="en-US" sz="120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globin</a:t>
                      </a:r>
                      <a:r>
                        <a:rPr lang="en-US" sz="1200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 </a:t>
                      </a:r>
                      <a:r>
                        <a:rPr lang="en-US" sz="1200" baseline="0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exon</a:t>
                      </a:r>
                      <a:r>
                        <a:rPr lang="en-US" sz="1200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  <a:sym typeface="Symbol"/>
                        </a:rPr>
                        <a:t> 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 TGGCAAGAAGGTGCTGACTTC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 GCAAAGGTGCCCTTGAGATC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l-GR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β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globin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200" baseline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exon</a:t>
                      </a:r>
                      <a:r>
                        <a:rPr lang="en-US" sz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 TGGGCAACCCTAAGGTGAAG 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 GTGAGCCAGGCCATCACTAAA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Primers for </a:t>
                      </a:r>
                      <a:r>
                        <a:rPr lang="en-US" sz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qRT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PCR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200" kern="1200" dirty="0" smtClean="0">
                        <a:solidFill>
                          <a:schemeClr val="dk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CL11A mRNA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 AACCCCAGCACTTAAGCAAA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 GGAGGTCATGATCCCCTT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l-GR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α</a:t>
                      </a:r>
                      <a:r>
                        <a:rPr lang="en-US" sz="120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-globin mRNA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: CTCAGAGAGAACCCACCATG</a:t>
                      </a:r>
                    </a:p>
                    <a:p>
                      <a:r>
                        <a:rPr lang="en-US" sz="120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: GGGAAGGACAGGAACATC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2</TotalTime>
  <Words>102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ivya</dc:creator>
  <cp:lastModifiedBy>Joyce Lloyd</cp:lastModifiedBy>
  <cp:revision>57</cp:revision>
  <cp:lastPrinted>2015-03-09T21:18:51Z</cp:lastPrinted>
  <dcterms:created xsi:type="dcterms:W3CDTF">2015-02-26T10:41:02Z</dcterms:created>
  <dcterms:modified xsi:type="dcterms:W3CDTF">2016-01-07T19:44:00Z</dcterms:modified>
</cp:coreProperties>
</file>